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420E8-BD4D-496F-BB01-F9C33A9145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D472B0-0616-429A-BF21-41E3FD5F8F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632EB0-C0B0-46A4-B6F7-3827CF70D3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78331-61A3-4D03-A6BE-250CF91A62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821AD9-E1FD-4785-98F5-9C9ED59D80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88042-563C-424E-ABCD-764B533D69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5B317-7EEF-4342-A445-9D60997D37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B5EA4-0296-40FB-ABCD-A2917828AD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7EF786-0D7F-4ED1-803C-92A3B10BA2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E7512D-EB0A-4A8B-8338-1C2675B240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0DD79-C312-454F-85BD-E75EEE394A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5F5A0-70A0-4F10-B52B-EE304A167A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AE3966-93D6-4FBE-8F2E-2ED25F144A0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45654" t="22529" r="8743" b="-875"/>
          <a:stretch/>
        </p:blipFill>
        <p:spPr>
          <a:xfrm>
            <a:off x="3449520" y="1773360"/>
            <a:ext cx="1995480" cy="29509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45610" t="14746" r="14044" b="6016"/>
          <a:stretch/>
        </p:blipFill>
        <p:spPr>
          <a:xfrm>
            <a:off x="1454040" y="1773360"/>
            <a:ext cx="1995480" cy="29509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518840" y="1440000"/>
            <a:ext cx="3877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       D       R       T      M          M       D       R       T        M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376280" y="5745240"/>
            <a:ext cx="4645080" cy="30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3. (a)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Sma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-digested genomic DNA resolved in PFGE and (b) Southern hybridisation with a labelled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vanB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robe of a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vanB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type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E. faecium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donor strain UW7706, a vancomycin-susceptible recipient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E. faecium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64/3 and a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vanB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positive transconjugant 1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Legend: M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S.aureu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x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Sm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. D, donor strain UW7706; R, recipent strain 64/3; T, transconjugant UW7706x64/3 TC1. Please note that th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vanB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ositive band in lanes D and T refers to a double band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206800" y="92088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294440" y="920880"/>
            <a:ext cx="45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05T10:01:14Z</dcterms:created>
  <dc:creator>wernerg</dc:creator>
  <dc:description/>
  <dc:language>en-US</dc:language>
  <cp:lastModifiedBy>wernerg</cp:lastModifiedBy>
  <dcterms:modified xsi:type="dcterms:W3CDTF">2012-04-12T12:16:23Z</dcterms:modified>
  <cp:revision>12</cp:revision>
  <dc:subject/>
  <dc:title>Folie 1</dc:title>
</cp:coreProperties>
</file>